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7" r:id="rId3"/>
    <p:sldId id="283" r:id="rId4"/>
    <p:sldId id="275" r:id="rId5"/>
    <p:sldId id="295" r:id="rId6"/>
  </p:sldIdLst>
  <p:sldSz cx="6858000" cy="12192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ministrator" initials="A" lastIdx="4" clrIdx="0"/>
  <p:cmAuthor id="2" name="少慧 柏" initials="少柏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3A1"/>
    <a:srgbClr val="A8BDE8"/>
    <a:srgbClr val="94E994"/>
    <a:srgbClr val="A0E0E7"/>
    <a:srgbClr val="D0B7D5"/>
    <a:srgbClr val="DFE4EF"/>
    <a:srgbClr val="F1EEDA"/>
    <a:srgbClr val="F0B8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461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handoutMaster" Target="handoutMasters/handoutMaster1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18.xml"/><Relationship Id="rId12" Type="http://schemas.openxmlformats.org/officeDocument/2006/relationships/commentAuthors" Target="commentAuthors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1080" y="1143000"/>
            <a:ext cx="173584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995508"/>
            <a:ext cx="5143500" cy="42450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6404254"/>
            <a:ext cx="5143500" cy="29438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649175"/>
            <a:ext cx="1478756" cy="1033317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649175"/>
            <a:ext cx="4350544" cy="1033317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3039834"/>
            <a:ext cx="5915025" cy="50720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8159849"/>
            <a:ext cx="5915025" cy="2667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3245875"/>
            <a:ext cx="2914650" cy="77364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3245875"/>
            <a:ext cx="2914650" cy="773647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49175"/>
            <a:ext cx="5915025" cy="23567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989029"/>
            <a:ext cx="2901255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4453905"/>
            <a:ext cx="2901255" cy="65510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989029"/>
            <a:ext cx="2915543" cy="14648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4453905"/>
            <a:ext cx="2915543" cy="65510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812880"/>
            <a:ext cx="2211883" cy="28450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755595"/>
            <a:ext cx="3471863" cy="866507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3657960"/>
            <a:ext cx="2211883" cy="677682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649175"/>
            <a:ext cx="5915025" cy="2356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3245875"/>
            <a:ext cx="5915025" cy="77364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11301291"/>
            <a:ext cx="2314575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11301291"/>
            <a:ext cx="1543050" cy="649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openxmlformats.org/officeDocument/2006/relationships/image" Target="../media/image8.jpeg"/><Relationship Id="rId7" Type="http://schemas.openxmlformats.org/officeDocument/2006/relationships/image" Target="../media/image7.jpeg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3.xml"/><Relationship Id="rId12" Type="http://schemas.openxmlformats.org/officeDocument/2006/relationships/tags" Target="../tags/tag2.xml"/><Relationship Id="rId11" Type="http://schemas.openxmlformats.org/officeDocument/2006/relationships/image" Target="../media/image10.jpeg"/><Relationship Id="rId10" Type="http://schemas.openxmlformats.org/officeDocument/2006/relationships/tags" Target="../tags/tag1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11.xml"/><Relationship Id="rId8" Type="http://schemas.openxmlformats.org/officeDocument/2006/relationships/tags" Target="../tags/tag10.xml"/><Relationship Id="rId7" Type="http://schemas.openxmlformats.org/officeDocument/2006/relationships/tags" Target="../tags/tag9.xml"/><Relationship Id="rId6" Type="http://schemas.openxmlformats.org/officeDocument/2006/relationships/tags" Target="../tags/tag8.xml"/><Relationship Id="rId5" Type="http://schemas.openxmlformats.org/officeDocument/2006/relationships/tags" Target="../tags/tag7.xml"/><Relationship Id="rId4" Type="http://schemas.openxmlformats.org/officeDocument/2006/relationships/tags" Target="../tags/tag6.xml"/><Relationship Id="rId3" Type="http://schemas.openxmlformats.org/officeDocument/2006/relationships/tags" Target="../tags/tag5.xml"/><Relationship Id="rId2" Type="http://schemas.openxmlformats.org/officeDocument/2006/relationships/image" Target="../media/image11.png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17.xml"/><Relationship Id="rId14" Type="http://schemas.openxmlformats.org/officeDocument/2006/relationships/tags" Target="../tags/tag16.xml"/><Relationship Id="rId13" Type="http://schemas.openxmlformats.org/officeDocument/2006/relationships/tags" Target="../tags/tag15.xml"/><Relationship Id="rId12" Type="http://schemas.openxmlformats.org/officeDocument/2006/relationships/tags" Target="../tags/tag14.xml"/><Relationship Id="rId11" Type="http://schemas.openxmlformats.org/officeDocument/2006/relationships/tags" Target="../tags/tag13.xml"/><Relationship Id="rId10" Type="http://schemas.openxmlformats.org/officeDocument/2006/relationships/tags" Target="../tags/tag12.xml"/><Relationship Id="rId1" Type="http://schemas.openxmlformats.org/officeDocument/2006/relationships/tags" Target="../tags/tag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MAPK signaling pathway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19430" y="1174115"/>
            <a:ext cx="1510665" cy="169862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513398" y="742950"/>
            <a:ext cx="167894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MAPK signaling pathway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 descr="apoptotic process"/>
          <p:cNvPicPr>
            <a:picLocks noChangeAspect="1"/>
          </p:cNvPicPr>
          <p:nvPr/>
        </p:nvPicPr>
        <p:blipFill>
          <a:blip r:embed="rId2"/>
          <a:srcRect r="580" b="49529"/>
          <a:stretch>
            <a:fillRect/>
          </a:stretch>
        </p:blipFill>
        <p:spPr>
          <a:xfrm>
            <a:off x="2790825" y="1317625"/>
            <a:ext cx="1325245" cy="144907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853531" y="742950"/>
            <a:ext cx="119126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apoptotic process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 descr="Leukocyte transendothelial migration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76165" y="1317625"/>
            <a:ext cx="1517650" cy="157480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4731385" y="742950"/>
            <a:ext cx="221234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Leukocyte transendothelial migration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28283" y="3096260"/>
            <a:ext cx="231013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negative regulation of apoptotic process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 descr="negative regulation of apoptotic process"/>
          <p:cNvPicPr>
            <a:picLocks noChangeAspect="1"/>
          </p:cNvPicPr>
          <p:nvPr/>
        </p:nvPicPr>
        <p:blipFill>
          <a:blip r:embed="rId4"/>
          <a:srcRect r="-1825" b="47290"/>
          <a:stretch>
            <a:fillRect/>
          </a:stretch>
        </p:blipFill>
        <p:spPr>
          <a:xfrm>
            <a:off x="406768" y="3613028"/>
            <a:ext cx="1917065" cy="1648460"/>
          </a:xfrm>
          <a:prstGeom prst="rect">
            <a:avLst/>
          </a:prstGeom>
        </p:spPr>
      </p:pic>
      <p:pic>
        <p:nvPicPr>
          <p:cNvPr id="16" name="图片 15" descr="G protein-coupled receptor signaling pathway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1925" y="3501390"/>
            <a:ext cx="1553210" cy="1787525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2432844" y="3096260"/>
            <a:ext cx="2577465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G protein-coupled receptor signaling pathway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 descr="Chemokine signaling pathway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76165" y="3670935"/>
            <a:ext cx="1751965" cy="161544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4940300" y="3096260"/>
            <a:ext cx="1795145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Chemokine signaling pathway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 descr="Natural killer cell mediated cytotoxicity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7033" y="6288405"/>
            <a:ext cx="1563370" cy="164592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52730" y="6006465"/>
            <a:ext cx="2423795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Natural killer cell mediated cytotoxicity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 descr="Viral protein interaction with cytokine and cytokine receptor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3109" y="8739273"/>
            <a:ext cx="1689735" cy="1529715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277494" y="8485824"/>
            <a:ext cx="4702493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Viral protein interaction with cytokine and cytokine receptor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 descr="1-UP-PI3k-akt"/>
          <p:cNvPicPr>
            <a:picLocks noChangeAspect="1"/>
          </p:cNvPicPr>
          <p:nvPr/>
        </p:nvPicPr>
        <p:blipFill>
          <a:blip r:embed="rId9"/>
          <a:srcRect r="-296" b="39000"/>
          <a:stretch>
            <a:fillRect/>
          </a:stretch>
        </p:blipFill>
        <p:spPr>
          <a:xfrm>
            <a:off x="2553335" y="6400165"/>
            <a:ext cx="1823720" cy="1715135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10"/>
            </p:custDataLst>
          </p:nvPr>
        </p:nvSpPr>
        <p:spPr>
          <a:xfrm>
            <a:off x="2614930" y="6004560"/>
            <a:ext cx="221234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>
                <a:latin typeface="Arial" panose="020B0604020202020204" pitchFamily="34" charset="0"/>
                <a:cs typeface="Arial" panose="020B0604020202020204" pitchFamily="34" charset="0"/>
              </a:rPr>
              <a:t>PI3K-Akt signaling pathway</a:t>
            </a:r>
            <a:endParaRPr lang="zh-CN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 descr="1-UP-in utero embryonic development"/>
          <p:cNvPicPr>
            <a:picLocks noChangeAspect="1"/>
          </p:cNvPicPr>
          <p:nvPr/>
        </p:nvPicPr>
        <p:blipFill>
          <a:blip r:embed="rId11"/>
          <a:srcRect r="49833" b="17"/>
          <a:stretch>
            <a:fillRect/>
          </a:stretch>
        </p:blipFill>
        <p:spPr>
          <a:xfrm>
            <a:off x="4850130" y="6290909"/>
            <a:ext cx="1543685" cy="1654810"/>
          </a:xfrm>
          <a:prstGeom prst="rect">
            <a:avLst/>
          </a:prstGeom>
        </p:spPr>
      </p:pic>
      <p:sp>
        <p:nvSpPr>
          <p:cNvPr id="26" name="文本框 25"/>
          <p:cNvSpPr txBox="1"/>
          <p:nvPr>
            <p:custDataLst>
              <p:tags r:id="rId12"/>
            </p:custDataLst>
          </p:nvPr>
        </p:nvSpPr>
        <p:spPr>
          <a:xfrm>
            <a:off x="4645660" y="6004560"/>
            <a:ext cx="2212340" cy="2298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 utero embryonic development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>
            <p:custDataLst>
              <p:tags r:id="rId13"/>
            </p:custDataLst>
          </p:nvPr>
        </p:nvSpPr>
        <p:spPr>
          <a:xfrm>
            <a:off x="306705" y="266700"/>
            <a:ext cx="342900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1</a:t>
            </a:r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pSp>
        <p:nvGrpSpPr>
          <p:cNvPr id="42" name="组合 41"/>
          <p:cNvGrpSpPr/>
          <p:nvPr/>
        </p:nvGrpSpPr>
        <p:grpSpPr>
          <a:xfrm>
            <a:off x="4336256" y="9355208"/>
            <a:ext cx="1778635" cy="929020"/>
            <a:chOff x="3709965" y="9225497"/>
            <a:chExt cx="2618445" cy="1642314"/>
          </a:xfrm>
        </p:grpSpPr>
        <p:cxnSp>
          <p:nvCxnSpPr>
            <p:cNvPr id="13" name="直接连接符 12"/>
            <p:cNvCxnSpPr/>
            <p:nvPr/>
          </p:nvCxnSpPr>
          <p:spPr>
            <a:xfrm>
              <a:off x="3709965" y="9356302"/>
              <a:ext cx="360000" cy="0"/>
            </a:xfrm>
            <a:prstGeom prst="line">
              <a:avLst/>
            </a:prstGeom>
            <a:ln w="38100">
              <a:solidFill>
                <a:srgbClr val="F0B8B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/>
          </p:nvCxnSpPr>
          <p:spPr>
            <a:xfrm>
              <a:off x="3709965" y="9606861"/>
              <a:ext cx="360000" cy="0"/>
            </a:xfrm>
            <a:prstGeom prst="line">
              <a:avLst/>
            </a:prstGeom>
            <a:ln w="38100">
              <a:solidFill>
                <a:srgbClr val="D0B7D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连接符 31"/>
            <p:cNvCxnSpPr/>
            <p:nvPr/>
          </p:nvCxnSpPr>
          <p:spPr>
            <a:xfrm>
              <a:off x="3709965" y="9857420"/>
              <a:ext cx="360000" cy="0"/>
            </a:xfrm>
            <a:prstGeom prst="line">
              <a:avLst/>
            </a:prstGeom>
            <a:ln w="38100">
              <a:solidFill>
                <a:srgbClr val="A0E0E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>
              <a:off x="3709965" y="10107979"/>
              <a:ext cx="360000" cy="0"/>
            </a:xfrm>
            <a:prstGeom prst="line">
              <a:avLst/>
            </a:prstGeom>
            <a:ln w="38100">
              <a:solidFill>
                <a:srgbClr val="94E99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>
              <a:off x="3709965" y="10358538"/>
              <a:ext cx="360000" cy="0"/>
            </a:xfrm>
            <a:prstGeom prst="line">
              <a:avLst/>
            </a:prstGeom>
            <a:ln w="38100">
              <a:solidFill>
                <a:srgbClr val="A8BDE8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/>
            <p:cNvCxnSpPr/>
            <p:nvPr/>
          </p:nvCxnSpPr>
          <p:spPr>
            <a:xfrm>
              <a:off x="3709965" y="10609098"/>
              <a:ext cx="360000" cy="0"/>
            </a:xfrm>
            <a:prstGeom prst="line">
              <a:avLst/>
            </a:prstGeom>
            <a:ln w="38100">
              <a:solidFill>
                <a:srgbClr val="D9D3A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/>
            <p:cNvSpPr txBox="1"/>
            <p:nvPr/>
          </p:nvSpPr>
          <p:spPr>
            <a:xfrm>
              <a:off x="4116070" y="9225497"/>
              <a:ext cx="2212340" cy="378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hysical Interactions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4116070" y="9478300"/>
              <a:ext cx="2212340" cy="378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-expressio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4116070" y="9731103"/>
              <a:ext cx="2212340" cy="378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athway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4116070" y="9983907"/>
              <a:ext cx="2212340" cy="378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enetic Interactions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4116070" y="10236708"/>
              <a:ext cx="2212340" cy="378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-localizatio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4116070" y="10489512"/>
              <a:ext cx="2212340" cy="378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hared protein domains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/>
          <p:cNvGrpSpPr/>
          <p:nvPr/>
        </p:nvGrpSpPr>
        <p:grpSpPr>
          <a:xfrm>
            <a:off x="1996450" y="1239264"/>
            <a:ext cx="2477770" cy="2246630"/>
            <a:chOff x="12025" y="1007"/>
            <a:chExt cx="6158" cy="5330"/>
          </a:xfrm>
        </p:grpSpPr>
        <p:grpSp>
          <p:nvGrpSpPr>
            <p:cNvPr id="23" name="组合 22"/>
            <p:cNvGrpSpPr/>
            <p:nvPr/>
          </p:nvGrpSpPr>
          <p:grpSpPr>
            <a:xfrm>
              <a:off x="12025" y="1007"/>
              <a:ext cx="6158" cy="5330"/>
              <a:chOff x="12025" y="1007"/>
              <a:chExt cx="6158" cy="5330"/>
            </a:xfrm>
          </p:grpSpPr>
          <p:grpSp>
            <p:nvGrpSpPr>
              <p:cNvPr id="21" name="组合 20"/>
              <p:cNvGrpSpPr/>
              <p:nvPr/>
            </p:nvGrpSpPr>
            <p:grpSpPr>
              <a:xfrm>
                <a:off x="12025" y="1007"/>
                <a:ext cx="6158" cy="5330"/>
                <a:chOff x="12025" y="1007"/>
                <a:chExt cx="6158" cy="5330"/>
              </a:xfrm>
            </p:grpSpPr>
            <p:pic>
              <p:nvPicPr>
                <p:cNvPr id="10" name="图片 9" descr="Venn"/>
                <p:cNvPicPr>
                  <a:picLocks noChangeAspect="1"/>
                </p:cNvPicPr>
                <p:nvPr>
                  <p:custDataLst>
                    <p:tags r:id="rId1"/>
                  </p:custDataLst>
                </p:nvPr>
              </p:nvPicPr>
              <p:blipFill>
                <a:blip r:embed="rId2"/>
                <a:srcRect t="13444"/>
                <a:stretch>
                  <a:fillRect/>
                </a:stretch>
              </p:blipFill>
              <p:spPr>
                <a:xfrm>
                  <a:off x="12025" y="1007"/>
                  <a:ext cx="6159" cy="5331"/>
                </a:xfrm>
                <a:prstGeom prst="rect">
                  <a:avLst/>
                </a:prstGeom>
              </p:spPr>
            </p:pic>
            <p:sp>
              <p:nvSpPr>
                <p:cNvPr id="11" name="矩形 10"/>
                <p:cNvSpPr/>
                <p:nvPr>
                  <p:custDataLst>
                    <p:tags r:id="rId3"/>
                  </p:custDataLst>
                </p:nvPr>
              </p:nvSpPr>
              <p:spPr>
                <a:xfrm>
                  <a:off x="12157" y="1684"/>
                  <a:ext cx="1078" cy="45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00"/>
                </a:p>
              </p:txBody>
            </p:sp>
          </p:grpSp>
          <p:sp>
            <p:nvSpPr>
              <p:cNvPr id="15" name="矩形 14"/>
              <p:cNvSpPr/>
              <p:nvPr>
                <p:custDataLst>
                  <p:tags r:id="rId4"/>
                </p:custDataLst>
              </p:nvPr>
            </p:nvSpPr>
            <p:spPr>
              <a:xfrm>
                <a:off x="13557" y="1007"/>
                <a:ext cx="1078" cy="45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  <p:sp>
            <p:nvSpPr>
              <p:cNvPr id="22" name="矩形 21"/>
              <p:cNvSpPr/>
              <p:nvPr>
                <p:custDataLst>
                  <p:tags r:id="rId5"/>
                </p:custDataLst>
              </p:nvPr>
            </p:nvSpPr>
            <p:spPr>
              <a:xfrm>
                <a:off x="15594" y="1007"/>
                <a:ext cx="1078" cy="45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24" name="矩形 23"/>
            <p:cNvSpPr/>
            <p:nvPr>
              <p:custDataLst>
                <p:tags r:id="rId6"/>
              </p:custDataLst>
            </p:nvPr>
          </p:nvSpPr>
          <p:spPr>
            <a:xfrm>
              <a:off x="17213" y="1684"/>
              <a:ext cx="971" cy="4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</p:grpSp>
      <p:sp>
        <p:nvSpPr>
          <p:cNvPr id="25" name="文本框 24"/>
          <p:cNvSpPr txBox="1"/>
          <p:nvPr>
            <p:custDataLst>
              <p:tags r:id="rId7"/>
            </p:custDataLst>
          </p:nvPr>
        </p:nvSpPr>
        <p:spPr>
          <a:xfrm>
            <a:off x="1331605" y="1678049"/>
            <a:ext cx="2009775" cy="183515"/>
          </a:xfrm>
          <a:prstGeom prst="rect">
            <a:avLst/>
          </a:prstGeom>
          <a:noFill/>
        </p:spPr>
        <p:txBody>
          <a:bodyPr wrap="square" rtlCol="0" anchor="b" anchorCtr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p DEGs of PBS WT vs PBS </a:t>
            </a:r>
            <a:r>
              <a:rPr lang="en-US" altLang="zh-CN" sz="6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-Flip</a:t>
            </a:r>
            <a:r>
              <a:rPr lang="en-US" altLang="zh-CN" sz="600" b="1" i="1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/-</a:t>
            </a:r>
            <a:endParaRPr lang="en-US" altLang="zh-CN" sz="600" b="1" i="1" baseline="300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7" name="文本框 26"/>
          <p:cNvSpPr txBox="1"/>
          <p:nvPr>
            <p:custDataLst>
              <p:tags r:id="rId8"/>
            </p:custDataLst>
          </p:nvPr>
        </p:nvSpPr>
        <p:spPr>
          <a:xfrm>
            <a:off x="3828425" y="1660269"/>
            <a:ext cx="2198370" cy="183515"/>
          </a:xfrm>
          <a:prstGeom prst="rect">
            <a:avLst/>
          </a:prstGeom>
          <a:noFill/>
        </p:spPr>
        <p:txBody>
          <a:bodyPr wrap="square" rtlCol="0" anchor="b" anchorCtr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own DEGs of PBS WT vs PBS </a:t>
            </a:r>
            <a:r>
              <a:rPr lang="en-US" altLang="zh-CN" sz="6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-Flip</a:t>
            </a:r>
            <a:r>
              <a:rPr lang="en-US" altLang="zh-CN" sz="600" b="1" i="1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/-</a:t>
            </a:r>
            <a:endParaRPr lang="en-US" altLang="zh-CN" sz="600" b="1" i="1" baseline="300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8" name="文本框 27"/>
          <p:cNvSpPr txBox="1"/>
          <p:nvPr>
            <p:custDataLst>
              <p:tags r:id="rId9"/>
            </p:custDataLst>
          </p:nvPr>
        </p:nvSpPr>
        <p:spPr>
          <a:xfrm>
            <a:off x="1562745" y="1404364"/>
            <a:ext cx="2195195" cy="183515"/>
          </a:xfrm>
          <a:prstGeom prst="rect">
            <a:avLst/>
          </a:prstGeom>
          <a:noFill/>
        </p:spPr>
        <p:txBody>
          <a:bodyPr wrap="square" rtlCol="0" anchor="b" anchorCtr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p DEGs of ZIKV WT vs ZIKV </a:t>
            </a:r>
            <a:r>
              <a:rPr lang="en-US" altLang="zh-CN" sz="6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-Flip</a:t>
            </a:r>
            <a:r>
              <a:rPr lang="en-US" altLang="zh-CN" sz="600" b="1" i="1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/-</a:t>
            </a:r>
            <a:endParaRPr lang="en-US" altLang="zh-CN" sz="600" b="1" i="1" baseline="300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9" name="文本框 28"/>
          <p:cNvSpPr txBox="1"/>
          <p:nvPr>
            <p:custDataLst>
              <p:tags r:id="rId10"/>
            </p:custDataLst>
          </p:nvPr>
        </p:nvSpPr>
        <p:spPr>
          <a:xfrm>
            <a:off x="3296295" y="1356104"/>
            <a:ext cx="2463800" cy="183515"/>
          </a:xfrm>
          <a:prstGeom prst="rect">
            <a:avLst/>
          </a:prstGeom>
          <a:noFill/>
        </p:spPr>
        <p:txBody>
          <a:bodyPr wrap="square" rtlCol="0" anchor="b" anchorCtr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own DEGs of ZIKV WT vs ZIKV </a:t>
            </a:r>
            <a:r>
              <a:rPr lang="en-US" altLang="zh-CN" sz="600" b="1" i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-Flip</a:t>
            </a:r>
            <a:r>
              <a:rPr lang="en-US" altLang="zh-CN" sz="600" b="1" i="1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/-</a:t>
            </a:r>
            <a:endParaRPr lang="en-US" altLang="zh-CN" sz="600" b="1" i="1" baseline="30000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30" name="文本框 29"/>
          <p:cNvSpPr txBox="1"/>
          <p:nvPr>
            <p:custDataLst>
              <p:tags r:id="rId11"/>
            </p:custDataLst>
          </p:nvPr>
        </p:nvSpPr>
        <p:spPr>
          <a:xfrm>
            <a:off x="3996055" y="2830830"/>
            <a:ext cx="1348105" cy="845185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txBody>
          <a:bodyPr wrap="square" rtlCol="0" anchor="t">
            <a:spAutoFit/>
          </a:bodyPr>
          <a:lstStyle/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1700026J14Rik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35438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8860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ENSMUSG00000121139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H4c6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36962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ENSMUSG00000120367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12"/>
            </p:custDataLst>
          </p:nvPr>
        </p:nvSpPr>
        <p:spPr>
          <a:xfrm>
            <a:off x="4378970" y="1843784"/>
            <a:ext cx="768985" cy="737235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txBody>
          <a:bodyPr wrap="square" rtlCol="0" anchor="t">
            <a:spAutoFit/>
          </a:bodyPr>
          <a:lstStyle/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Rpl35a-ps6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Calm4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Dnah3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17383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Tcf23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Wdr95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13"/>
            </p:custDataLst>
          </p:nvPr>
        </p:nvSpPr>
        <p:spPr>
          <a:xfrm>
            <a:off x="1672600" y="2988054"/>
            <a:ext cx="773430" cy="306705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txBody>
          <a:bodyPr wrap="square" rtlCol="0" anchor="t">
            <a:spAutoFit/>
          </a:bodyPr>
          <a:lstStyle/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49333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48795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14"/>
            </p:custDataLst>
          </p:nvPr>
        </p:nvSpPr>
        <p:spPr>
          <a:xfrm>
            <a:off x="1391930" y="1951734"/>
            <a:ext cx="627380" cy="521970"/>
          </a:xfrm>
          <a:prstGeom prst="rect">
            <a:avLst/>
          </a:prstGeom>
          <a:noFill/>
          <a:ln>
            <a:solidFill>
              <a:schemeClr val="accent1"/>
            </a:solidFill>
            <a:prstDash val="sysDash"/>
          </a:ln>
        </p:spPr>
        <p:txBody>
          <a:bodyPr wrap="square" rtlCol="0" anchor="t">
            <a:spAutoFit/>
          </a:bodyPr>
          <a:lstStyle/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nat3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Cd300ld3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Gm28784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zh-CN" altLang="en-US" sz="700" b="1">
                <a:latin typeface="Arial" panose="020B0604020202020204" pitchFamily="34" charset="0"/>
                <a:cs typeface="Arial" panose="020B0604020202020204" pitchFamily="34" charset="0"/>
              </a:rPr>
              <a:t>Fnd3c2</a:t>
            </a:r>
            <a:endParaRPr lang="zh-CN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51155" y="406400"/>
            <a:ext cx="342900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S2</a:t>
            </a:r>
            <a:endParaRPr lang="en-US" altLang="zh-CN" sz="1200" b="1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sp>
        <p:nvSpPr>
          <p:cNvPr id="76" name="文本框 75"/>
          <p:cNvSpPr txBox="1"/>
          <p:nvPr>
            <p:custDataLst>
              <p:tags r:id="rId15"/>
            </p:custDataLst>
          </p:nvPr>
        </p:nvSpPr>
        <p:spPr>
          <a:xfrm>
            <a:off x="848780" y="2583521"/>
            <a:ext cx="1518920" cy="25654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ctr">
              <a:lnSpc>
                <a:spcPct val="150000"/>
              </a:lnSpc>
            </a:pPr>
            <a:endParaRPr lang="zh-CN" altLang="en-US" sz="700" b="1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/>
          <p:nvPr/>
        </p:nvGraphicFramePr>
        <p:xfrm>
          <a:off x="448310" y="972035"/>
          <a:ext cx="6172200" cy="2288540"/>
        </p:xfrm>
        <a:graphic>
          <a:graphicData uri="http://schemas.openxmlformats.org/drawingml/2006/table">
            <a:tbl>
              <a:tblPr/>
              <a:tblGrid>
                <a:gridCol w="625475"/>
                <a:gridCol w="341630"/>
                <a:gridCol w="557530"/>
                <a:gridCol w="781685"/>
                <a:gridCol w="556895"/>
                <a:gridCol w="557530"/>
                <a:gridCol w="557530"/>
                <a:gridCol w="521970"/>
                <a:gridCol w="556895"/>
                <a:gridCol w="557530"/>
                <a:gridCol w="557530"/>
              </a:tblGrid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Summary statistics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Raw Data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Valid Data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Valid Data base(Gb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Total mapped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Read map to'+'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Read map to'-'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Multiply mapped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Uniquely mapped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Non-splice reads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Splicereads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WT1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4999468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8875882(97.7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33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7547950(97.28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2793769(46.6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2819696(46.6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934485(3.9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5613465(93.3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7837672(56.9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7775793(36.3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WT2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4963040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8563890(97.85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28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7092753(96.9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2637591(46.6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2659324(46.6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795838(3.7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5296915(93.2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7005261(55.6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291654(37.6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WT3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41191910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0168350(97.5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6.03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8699558(96.3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555182(46.1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576293(46.25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68083(3.9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7131475(92.4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3022722(57.3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4108753(35.1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WT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4680940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5766080(97.7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6.86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4472791(97.1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1346053(46.6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1367535(46.6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759203(3.8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2713588(93.3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6380967(57.6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6332621(35.6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45791776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4831052(97.9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6.72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3301752(96.5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0842176(46.4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0863356(46.5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96220(3.5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1705532(93.0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924552(55.6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6780980(37.4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53375430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2202514(97.8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83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0509509(96.7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268468(46.4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286858(46.5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954183(3.7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8555326(93.0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9032695(55.6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9522631(37.4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51951026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0805150(97.7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62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9557495(97.5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3817769(46.88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3837915(46.9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901811(3.7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7655684(93.8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8903749(56.8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751935(36.9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PBS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5416707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2921766(97.7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94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1385088(97.1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638742(46.5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660647(46.6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085699(3.9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9299389(93.1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0230578(57.1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9068811(36.0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WT1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40058932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9107274(97.85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.87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7638741(96.2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090602(46.2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116597(46.3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431542(3.6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6207199(92.58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2181788(56.7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4025411(35.8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WT2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3758812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6750284(97.7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.51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5644327(96.9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7154492(46.68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7172675(46.7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317160(3.58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4327167(93.4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0796234(56.5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3530933(36.8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WT3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52771532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1523848(97.6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73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9930969(96.9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026240(46.6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4055798(46.6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48931(3.5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8082038(93.3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9602211(57.45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479827(35.8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WT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33697350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2888778(97.7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.93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1695028(96.3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240290(46.3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264327(46.4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190411(3.6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0504617(92.75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970508(57.68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1534109(35.0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3486862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4120596(97.6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.12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2735111(95.9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778144(46.2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785736(46.2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171231(3.4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1563880(92.5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9473041(57.0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2090839(35.4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50975108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9834318(97.7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7.48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8182595(96.6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3180308(46.5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3194790(46.5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07497(3.63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6375098(93.0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8497759(57.1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7877339(35.8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36709546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5835648(97.6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5.38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4475572(96.2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6590154(46.3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6616166(46.37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269252(3.5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3206320(92.6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20520098(57.26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2686222(35.4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ZIKV </a:t>
                      </a:r>
                      <a:r>
                        <a:rPr lang="en-US" sz="500" b="0" i="1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c-Flip</a:t>
                      </a:r>
                      <a:r>
                        <a:rPr lang="en-US" sz="500" b="0" i="1" baseline="3000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+/-</a:t>
                      </a: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Courier New" panose="02070309020205020404" charset="-122"/>
                        </a:rPr>
                        <a:t>33939136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Courier New" panose="02070309020205020404" charset="-122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3190270(97.60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4.98G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2057649(96.5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447601(46.5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5464542(46.59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145506(3.45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30912143(93.14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8292068(55.11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500" b="0">
                          <a:solidFill>
                            <a:srgbClr val="000000"/>
                          </a:solidFill>
                          <a:latin typeface="宋体" panose="02010600030101010101" pitchFamily="2" charset="-122"/>
                        </a:rPr>
                        <a:t>12620075(38.02%)</a:t>
                      </a:r>
                      <a:endParaRPr lang="en-US" altLang="en-US" sz="500" b="0">
                        <a:solidFill>
                          <a:srgbClr val="000000"/>
                        </a:solidFill>
                        <a:latin typeface="宋体" panose="02010600030101010101" pitchFamily="2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63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389255" y="577215"/>
            <a:ext cx="342900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en-US" sz="1000" b="1" dirty="0">
                <a:latin typeface="Times New Roman" panose="02020603050405020304" pitchFamily="18" charset="0"/>
                <a:sym typeface="+mn-ea"/>
              </a:rPr>
              <a:t>Table S1</a:t>
            </a:r>
            <a:endParaRPr lang="en-US" altLang="en-US" sz="1000" b="1" dirty="0">
              <a:latin typeface="Times New Roman" panose="02020603050405020304" pitchFamily="18" charset="0"/>
              <a:sym typeface="+mn-ea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89255" y="577215"/>
            <a:ext cx="342900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</a:t>
            </a:r>
            <a:r>
              <a:rPr lang="en-US" sz="1000" b="1" dirty="0">
                <a:latin typeface="Times New Roman" panose="02020603050405020304" pitchFamily="18" charset="0"/>
                <a:sym typeface="+mn-ea"/>
              </a:rPr>
              <a:t>Table S2</a:t>
            </a:r>
            <a:endParaRPr lang="en-US" altLang="en-US" sz="1000" b="1" dirty="0">
              <a:latin typeface="Times New Roman" panose="02020603050405020304" pitchFamily="18" charset="0"/>
              <a:sym typeface="+mn-ea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446" y="1105757"/>
            <a:ext cx="5023108" cy="5289822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COMMONDATA" val="eyJoZGlkIjoiNzJkMDM5OGRhNWU0YTdhZTVhNjVjZDRhY2ExN2ZhNTUifQ=="/>
  <p:tag name="commondata" val="eyJoZGlkIjoiODNiYmNmZDhmMjIyYWU3ZmRlZGI0NzhkNzU0Nzg2ZTUifQ==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78</Words>
  <Application>WPS 演示</Application>
  <PresentationFormat>宽屏</PresentationFormat>
  <Paragraphs>44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Courier New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an</cp:lastModifiedBy>
  <cp:revision>67</cp:revision>
  <dcterms:created xsi:type="dcterms:W3CDTF">2023-08-09T12:44:00Z</dcterms:created>
  <dcterms:modified xsi:type="dcterms:W3CDTF">2024-10-30T02:1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524FB0AD9C5404CA619A1881C0C5C47_13</vt:lpwstr>
  </property>
  <property fmtid="{D5CDD505-2E9C-101B-9397-08002B2CF9AE}" pid="3" name="KSOProductBuildVer">
    <vt:lpwstr>2052-12.1.0.18608</vt:lpwstr>
  </property>
</Properties>
</file>